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98167-BBD3-415D-96FF-270D485027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AE5FF-8EFF-47BE-A7DF-A5865D8C08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815B5-242E-4C4D-B80F-6D9781589C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549CB-AEA1-41E5-B52C-9615ADCCCA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32186-F154-476A-9DF7-0736C5A18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5AD74-AA58-44EB-8EBE-694E8B7D29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34494-657F-4036-9E2E-AE43BAB8F3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453CE-ACCB-4A93-A36D-A4A17E1111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0DC14-586A-48A0-8805-23F3EF7BDF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2E199-91C9-42B7-9DBE-FD830B8C58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6D1F9-1BA2-4C2A-8594-D35CC1D96A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54C1B-746C-4051-AE21-DAE77BA96B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6E8790-AE43-47A6-9471-80308F9F971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9"/>
          <p:cNvGrpSpPr/>
          <p:nvPr/>
        </p:nvGrpSpPr>
        <p:grpSpPr>
          <a:xfrm>
            <a:off x="541440" y="-12600"/>
            <a:ext cx="8276400" cy="5941800"/>
            <a:chOff x="541440" y="-12600"/>
            <a:chExt cx="8276400" cy="5941800"/>
          </a:xfrm>
        </p:grpSpPr>
        <p:grpSp>
          <p:nvGrpSpPr>
            <p:cNvPr id="42" name="组合 26"/>
            <p:cNvGrpSpPr/>
            <p:nvPr/>
          </p:nvGrpSpPr>
          <p:grpSpPr>
            <a:xfrm>
              <a:off x="1072080" y="4035240"/>
              <a:ext cx="2356920" cy="1893960"/>
              <a:chOff x="1072080" y="4035240"/>
              <a:chExt cx="2356920" cy="1893960"/>
            </a:xfrm>
          </p:grpSpPr>
          <p:pic>
            <p:nvPicPr>
              <p:cNvPr id="43" name="Picture 3" descr="C:\Documents and Settings\Administrator\桌面\Os03g08320.tif"/>
              <p:cNvPicPr/>
              <p:nvPr/>
            </p:nvPicPr>
            <p:blipFill>
              <a:blip r:embed="rId1"/>
              <a:srcRect l="11722" t="5563" r="8199" b="0"/>
              <a:stretch/>
            </p:blipFill>
            <p:spPr>
              <a:xfrm>
                <a:off x="1072080" y="4035240"/>
                <a:ext cx="2356920" cy="1893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TextBox 7"/>
              <p:cNvSpPr/>
              <p:nvPr/>
            </p:nvSpPr>
            <p:spPr>
              <a:xfrm>
                <a:off x="1524600" y="4122360"/>
                <a:ext cx="1642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JAZ1:Os03g083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5" name="组合 28"/>
            <p:cNvGrpSpPr/>
            <p:nvPr/>
          </p:nvGrpSpPr>
          <p:grpSpPr>
            <a:xfrm>
              <a:off x="929160" y="-12600"/>
              <a:ext cx="2499840" cy="1914120"/>
              <a:chOff x="929160" y="-12600"/>
              <a:chExt cx="2499840" cy="1914120"/>
            </a:xfrm>
          </p:grpSpPr>
          <p:pic>
            <p:nvPicPr>
              <p:cNvPr id="46" name="Picture 5" descr="C:\Documents and Settings\Administrator\桌面\Os03g49380.tif"/>
              <p:cNvPicPr/>
              <p:nvPr/>
            </p:nvPicPr>
            <p:blipFill>
              <a:blip r:embed="rId2"/>
              <a:srcRect l="7815" t="5563" r="6250" b="0"/>
              <a:stretch/>
            </p:blipFill>
            <p:spPr>
              <a:xfrm>
                <a:off x="929160" y="-12600"/>
                <a:ext cx="2499840" cy="1914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Box 13"/>
              <p:cNvSpPr/>
              <p:nvPr/>
            </p:nvSpPr>
            <p:spPr>
              <a:xfrm>
                <a:off x="1628280" y="81720"/>
                <a:ext cx="1559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LOX:Os03g493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组合 29"/>
            <p:cNvGrpSpPr/>
            <p:nvPr/>
          </p:nvGrpSpPr>
          <p:grpSpPr>
            <a:xfrm>
              <a:off x="6143400" y="34560"/>
              <a:ext cx="2428560" cy="1881360"/>
              <a:chOff x="6143400" y="34560"/>
              <a:chExt cx="2428560" cy="1881360"/>
            </a:xfrm>
          </p:grpSpPr>
          <p:pic>
            <p:nvPicPr>
              <p:cNvPr id="49" name="Picture 6" descr="C:\Documents and Settings\Administrator\桌面\Os12g26290.tif"/>
              <p:cNvPicPr/>
              <p:nvPr/>
            </p:nvPicPr>
            <p:blipFill>
              <a:blip r:embed="rId3"/>
              <a:srcRect l="11722" t="8337" r="6250" b="0"/>
              <a:stretch/>
            </p:blipFill>
            <p:spPr>
              <a:xfrm>
                <a:off x="6143400" y="34560"/>
                <a:ext cx="2428560" cy="1881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TextBox 14"/>
              <p:cNvSpPr/>
              <p:nvPr/>
            </p:nvSpPr>
            <p:spPr>
              <a:xfrm>
                <a:off x="6575760" y="58680"/>
                <a:ext cx="1581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DOX1:Os12g2629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TextBox 11"/>
            <p:cNvSpPr/>
            <p:nvPr/>
          </p:nvSpPr>
          <p:spPr>
            <a:xfrm rot="16200000">
              <a:off x="-881280" y="2124360"/>
              <a:ext cx="3214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expression lev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2"/>
            <p:cNvSpPr/>
            <p:nvPr/>
          </p:nvSpPr>
          <p:spPr>
            <a:xfrm rot="16200000">
              <a:off x="7740720" y="2838960"/>
              <a:ext cx="1785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PKM valu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组合 42"/>
            <p:cNvGrpSpPr/>
            <p:nvPr/>
          </p:nvGrpSpPr>
          <p:grpSpPr>
            <a:xfrm>
              <a:off x="6670440" y="4630680"/>
              <a:ext cx="1330200" cy="533520"/>
              <a:chOff x="6670440" y="4630680"/>
              <a:chExt cx="1330200" cy="533520"/>
            </a:xfrm>
          </p:grpSpPr>
          <p:sp>
            <p:nvSpPr>
              <p:cNvPr id="54" name="Rectangle 12"/>
              <p:cNvSpPr/>
              <p:nvPr/>
            </p:nvSpPr>
            <p:spPr>
              <a:xfrm>
                <a:off x="6670440" y="4703400"/>
                <a:ext cx="88560" cy="75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3"/>
              <p:cNvSpPr/>
              <p:nvPr/>
            </p:nvSpPr>
            <p:spPr>
              <a:xfrm>
                <a:off x="6705360" y="4630680"/>
                <a:ext cx="129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al-time PC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4"/>
              <p:cNvSpPr/>
              <p:nvPr/>
            </p:nvSpPr>
            <p:spPr>
              <a:xfrm>
                <a:off x="6670440" y="4991040"/>
                <a:ext cx="88560" cy="759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15"/>
              <p:cNvSpPr/>
              <p:nvPr/>
            </p:nvSpPr>
            <p:spPr>
              <a:xfrm>
                <a:off x="6746760" y="4917960"/>
                <a:ext cx="69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NA-Seq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组合 22"/>
            <p:cNvGrpSpPr/>
            <p:nvPr/>
          </p:nvGrpSpPr>
          <p:grpSpPr>
            <a:xfrm>
              <a:off x="3476520" y="4047120"/>
              <a:ext cx="2571120" cy="1855440"/>
              <a:chOff x="3476520" y="4047120"/>
              <a:chExt cx="2571120" cy="1855440"/>
            </a:xfrm>
          </p:grpSpPr>
          <p:pic>
            <p:nvPicPr>
              <p:cNvPr id="59" name="Picture 3" descr="C:\Documents and Settings\Administrator\桌面\JAZ7_Os09g26780.tif"/>
              <p:cNvPicPr/>
              <p:nvPr/>
            </p:nvPicPr>
            <p:blipFill>
              <a:blip r:embed="rId4"/>
              <a:srcRect l="6526" t="6459" r="6526" b="0"/>
              <a:stretch/>
            </p:blipFill>
            <p:spPr>
              <a:xfrm>
                <a:off x="3476520" y="4047120"/>
                <a:ext cx="2571120" cy="1855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矩形 24"/>
              <p:cNvSpPr/>
              <p:nvPr/>
            </p:nvSpPr>
            <p:spPr>
              <a:xfrm>
                <a:off x="4154760" y="4106520"/>
                <a:ext cx="1303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JAZ7:Os09g267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组合 30"/>
            <p:cNvGrpSpPr/>
            <p:nvPr/>
          </p:nvGrpSpPr>
          <p:grpSpPr>
            <a:xfrm>
              <a:off x="845640" y="1987560"/>
              <a:ext cx="2662200" cy="1928520"/>
              <a:chOff x="845640" y="1987560"/>
              <a:chExt cx="2662200" cy="1928520"/>
            </a:xfrm>
          </p:grpSpPr>
          <p:pic>
            <p:nvPicPr>
              <p:cNvPr id="62" name="Picture 4" descr="C:\Documents and Settings\Administrator\桌面\ACX_Os05g14010.tif"/>
              <p:cNvPicPr/>
              <p:nvPr/>
            </p:nvPicPr>
            <p:blipFill>
              <a:blip r:embed="rId5"/>
              <a:srcRect l="6250" t="5563" r="5856" b="0"/>
              <a:stretch/>
            </p:blipFill>
            <p:spPr>
              <a:xfrm>
                <a:off x="845640" y="1987560"/>
                <a:ext cx="2662200" cy="1928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3" name="矩形 32"/>
              <p:cNvSpPr/>
              <p:nvPr/>
            </p:nvSpPr>
            <p:spPr>
              <a:xfrm>
                <a:off x="1538280" y="2097360"/>
                <a:ext cx="1265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ACX:Os05g140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组合 33"/>
            <p:cNvGrpSpPr/>
            <p:nvPr/>
          </p:nvGrpSpPr>
          <p:grpSpPr>
            <a:xfrm>
              <a:off x="3429360" y="-12600"/>
              <a:ext cx="2642760" cy="1927080"/>
              <a:chOff x="3429360" y="-12600"/>
              <a:chExt cx="2642760" cy="1927080"/>
            </a:xfrm>
          </p:grpSpPr>
          <p:pic>
            <p:nvPicPr>
              <p:cNvPr id="65" name="Picture 5" descr="C:\Documents and Settings\Administrator\桌面\LOX_Os12g37260.tif"/>
              <p:cNvPicPr/>
              <p:nvPr/>
            </p:nvPicPr>
            <p:blipFill>
              <a:blip r:embed="rId6"/>
              <a:srcRect l="7815" t="5563" r="4291" b="0"/>
              <a:stretch/>
            </p:blipFill>
            <p:spPr>
              <a:xfrm>
                <a:off x="3429360" y="-12600"/>
                <a:ext cx="2642760" cy="1927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矩形 35"/>
              <p:cNvSpPr/>
              <p:nvPr/>
            </p:nvSpPr>
            <p:spPr>
              <a:xfrm>
                <a:off x="4071240" y="76680"/>
                <a:ext cx="125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LOX:Os12g372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组合 36"/>
            <p:cNvGrpSpPr/>
            <p:nvPr/>
          </p:nvGrpSpPr>
          <p:grpSpPr>
            <a:xfrm>
              <a:off x="3512520" y="1987560"/>
              <a:ext cx="2523960" cy="1933920"/>
              <a:chOff x="3512520" y="1987560"/>
              <a:chExt cx="2523960" cy="1933920"/>
            </a:xfrm>
          </p:grpSpPr>
          <p:pic>
            <p:nvPicPr>
              <p:cNvPr id="68" name="Picture 6" descr="C:\Documents and Settings\Administrator\桌面\FadA_Os12g04500.tif"/>
              <p:cNvPicPr/>
              <p:nvPr/>
            </p:nvPicPr>
            <p:blipFill>
              <a:blip r:embed="rId7"/>
              <a:srcRect l="9764" t="5563" r="6250" b="0"/>
              <a:stretch/>
            </p:blipFill>
            <p:spPr>
              <a:xfrm>
                <a:off x="3512520" y="1987560"/>
                <a:ext cx="2523960" cy="1933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" name="矩形 38"/>
              <p:cNvSpPr/>
              <p:nvPr/>
            </p:nvSpPr>
            <p:spPr>
              <a:xfrm>
                <a:off x="4119840" y="2101680"/>
                <a:ext cx="133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FadA:Os12g045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" name="组合 39"/>
            <p:cNvGrpSpPr/>
            <p:nvPr/>
          </p:nvGrpSpPr>
          <p:grpSpPr>
            <a:xfrm>
              <a:off x="6143400" y="1999440"/>
              <a:ext cx="2356920" cy="1916640"/>
              <a:chOff x="6143400" y="1999440"/>
              <a:chExt cx="2356920" cy="1916640"/>
            </a:xfrm>
          </p:grpSpPr>
          <p:pic>
            <p:nvPicPr>
              <p:cNvPr id="71" name="Picture 7" descr="C:\Documents and Settings\Administrator\桌面\MFP2_Os05g06300.tif"/>
              <p:cNvPicPr/>
              <p:nvPr/>
            </p:nvPicPr>
            <p:blipFill>
              <a:blip r:embed="rId8"/>
              <a:srcRect l="9764" t="5563" r="8199" b="0"/>
              <a:stretch/>
            </p:blipFill>
            <p:spPr>
              <a:xfrm>
                <a:off x="6143400" y="1999440"/>
                <a:ext cx="2356920" cy="1916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2" name="矩形 41"/>
              <p:cNvSpPr/>
              <p:nvPr/>
            </p:nvSpPr>
            <p:spPr>
              <a:xfrm>
                <a:off x="6666120" y="2101320"/>
                <a:ext cx="15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alibri"/>
                  </a:rPr>
                  <a:t>MFP2:Os05g063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3" name="Text Box 18"/>
          <p:cNvSpPr/>
          <p:nvPr/>
        </p:nvSpPr>
        <p:spPr>
          <a:xfrm>
            <a:off x="357120" y="5977080"/>
            <a:ext cx="85726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alidation of JA related genes by qRT-PCR. Eight JA related genes were tested by qRT-PCR assays. qRT-PCR quantification values were compared with HHZ_ck. Error bars indicate the standard deviation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in 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s used as an endogenous contro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Lenovo User</cp:lastModifiedBy>
  <dcterms:modified xsi:type="dcterms:W3CDTF">2014-10-11T08:35:19Z</dcterms:modified>
  <cp:revision>18</cp:revision>
  <dc:subject/>
  <dc:title>幻灯片 1</dc:title>
</cp:coreProperties>
</file>